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DDABFEE-860B-4917-A3A6-1EC2E73B4C2E}" v="155" dt="2026-02-16T13:11:10.01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>
        <p:scale>
          <a:sx n="125" d="100"/>
          <a:sy n="125" d="100"/>
        </p:scale>
        <p:origin x="60" y="-9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DB4199-51E3-A89A-5FA4-E65CC55514F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8A680E9-E842-A2AD-EDFC-5094A17482B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7E58E5-9AAE-E1EC-290D-D99531750F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D071C-5AC3-4AB9-AF9E-C9FEDAAF0E3C}" type="datetimeFigureOut">
              <a:rPr lang="en-GB" smtClean="0"/>
              <a:t>16/02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93861D-604D-42A7-7FD4-6B0C4A28EA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0C79E3-01C0-B654-5AB2-99E129D50E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9FCE0C-043D-4286-BAE9-6DB474B216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57830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6F26B3-DA78-AE71-FD4F-407EA3F21F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0554C56-AFF8-FEA5-0908-CD711DCACF3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C66706-8D14-EF8F-218F-30B710CA23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D071C-5AC3-4AB9-AF9E-C9FEDAAF0E3C}" type="datetimeFigureOut">
              <a:rPr lang="en-GB" smtClean="0"/>
              <a:t>16/02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540068-1AB0-3205-4A1E-18EB3C37F9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F45E842-A512-06CF-1F1D-FD337CD9C1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9FCE0C-043D-4286-BAE9-6DB474B216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26658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0961D07-BC27-F323-8358-C216B46593D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B143C12-4E21-432D-F32C-37D5938642A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BE885AA-5FD1-E244-6E02-69E044D0B6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D071C-5AC3-4AB9-AF9E-C9FEDAAF0E3C}" type="datetimeFigureOut">
              <a:rPr lang="en-GB" smtClean="0"/>
              <a:t>16/02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302746F-9803-52D2-AC16-37E7A0B9FB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04ECE8-E0F1-60D6-0B55-CB46F099A6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9FCE0C-043D-4286-BAE9-6DB474B216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87799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9DC5ED-F66C-6C3E-5584-D824C94A21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D92CA0F-1E44-A122-30D4-8E644C302F0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4EED28-E65C-C7A4-805E-6F7E2BB2F4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D071C-5AC3-4AB9-AF9E-C9FEDAAF0E3C}" type="datetimeFigureOut">
              <a:rPr lang="en-GB" smtClean="0"/>
              <a:t>16/02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6E8230-8145-D448-A6CB-A5E5B30E9A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8DC967D-B43B-DA00-5EFB-31706BCE39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9FCE0C-043D-4286-BAE9-6DB474B216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65906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82C73E-0B73-EFE0-9164-964BB91FAD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8758EAE-BB28-1262-7155-920E34EAC0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73A0A92-FC0F-A94E-3D69-C2BEE0697A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D071C-5AC3-4AB9-AF9E-C9FEDAAF0E3C}" type="datetimeFigureOut">
              <a:rPr lang="en-GB" smtClean="0"/>
              <a:t>16/02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BDB2E5-9CBE-F34F-2478-A5DFA7C52A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DCCF75-1E50-EA7E-1685-81E686811A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9FCE0C-043D-4286-BAE9-6DB474B216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50186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B356DC-E2AB-29F6-8903-6B9EF34BA5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12F77AB-C45B-A5EC-3C2D-CA287E1FBDD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DD0E9CE-1225-51BD-5E09-6E1B2BB3470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E0A50C6-7D6E-29F7-0EBD-EA9B03D62E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D071C-5AC3-4AB9-AF9E-C9FEDAAF0E3C}" type="datetimeFigureOut">
              <a:rPr lang="en-GB" smtClean="0"/>
              <a:t>16/02/2026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5575166-CA22-FB4A-713B-DD283226EE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60DAAB1-D18F-C224-0E84-A5FBDC2DDD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9FCE0C-043D-4286-BAE9-6DB474B216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394200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A67981-B63F-BED9-A901-572E5E2580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9517003-582F-7385-02A4-46856D2054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6960B79-86A9-F03C-DD1F-AE6B3482336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6F2DD7F-DD81-608C-C37A-778553C371F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CCD8F19-1A20-8494-D6D7-2164792D2F3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EA40D84-FCCF-2CB9-A4D7-E6DBC450A5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D071C-5AC3-4AB9-AF9E-C9FEDAAF0E3C}" type="datetimeFigureOut">
              <a:rPr lang="en-GB" smtClean="0"/>
              <a:t>16/02/2026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7F747D5-270E-2107-1981-C6843F39DA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87DBA2A-9F54-E0E6-E8A4-0429D60B49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9FCE0C-043D-4286-BAE9-6DB474B216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56497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00F6CB-47C2-1828-72B1-6F41B5FAFE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37CCCB6-0848-CC75-AFA1-BC72EB880C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D071C-5AC3-4AB9-AF9E-C9FEDAAF0E3C}" type="datetimeFigureOut">
              <a:rPr lang="en-GB" smtClean="0"/>
              <a:t>16/02/2026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746E99D-A4C4-85C5-BB79-F7BB7EB843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FDA1130-DE4E-B945-AB64-8FDF8D585D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9FCE0C-043D-4286-BAE9-6DB474B216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849222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16C9DD5-2E38-9958-37C9-E4B3686898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D071C-5AC3-4AB9-AF9E-C9FEDAAF0E3C}" type="datetimeFigureOut">
              <a:rPr lang="en-GB" smtClean="0"/>
              <a:t>16/02/2026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5937176-8AA2-8DE2-B204-19B6042DE0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079817B-DCD6-6E26-AF88-C57C8C375F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9FCE0C-043D-4286-BAE9-6DB474B216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277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CACEA3-C67A-6A09-7B49-CEC0C71D4D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A5995F8-F800-35AE-6F25-E48043F07B9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92874CE-3140-C609-2AA8-541EBAC751A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FD6BCD8-7D48-129D-7B09-1EBD1B0774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D071C-5AC3-4AB9-AF9E-C9FEDAAF0E3C}" type="datetimeFigureOut">
              <a:rPr lang="en-GB" smtClean="0"/>
              <a:t>16/02/2026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C0CAD86-D024-5D58-DBDB-FCB17E5438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71E62A5-5C63-B254-5238-21E8A8467D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9FCE0C-043D-4286-BAE9-6DB474B216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77486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774D32-E5D6-87E9-A9C9-1105D6D11A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96D2465-857F-4BD3-8C29-3F0B6644AA3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5AE7C57-3082-AFAB-5005-6E9A8C8DE47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C390291-E28B-623C-7E13-B40011D86C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D071C-5AC3-4AB9-AF9E-C9FEDAAF0E3C}" type="datetimeFigureOut">
              <a:rPr lang="en-GB" smtClean="0"/>
              <a:t>16/02/2026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471593F-F807-83D5-EE92-2D09266846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6E97932-1F27-ABCA-C760-556D324BAE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9FCE0C-043D-4286-BAE9-6DB474B216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5788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B7C20D6-923F-61AB-3B9C-6A7F92BC13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42E332D-6D34-9BCB-6AFE-AAEA188B1F2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56D4F6-A67D-2E12-D08C-96EADBD678F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8ED071C-5AC3-4AB9-AF9E-C9FEDAAF0E3C}" type="datetimeFigureOut">
              <a:rPr lang="en-GB" smtClean="0"/>
              <a:t>16/02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56E013-9A11-4858-BC79-80C7664CA9E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3C1CA5-45BE-8A1B-AF18-E50CAE90F5A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F9FCE0C-043D-4286-BAE9-6DB474B216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823822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microsoft.com/office/2007/relationships/hdphoto" Target="../media/hdphoto1.wdp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BE20D1D-E1EA-1DF5-45B6-1297C4677575}"/>
              </a:ext>
            </a:extLst>
          </p:cNvPr>
          <p:cNvSpPr txBox="1"/>
          <p:nvPr/>
        </p:nvSpPr>
        <p:spPr>
          <a:xfrm>
            <a:off x="380934" y="700134"/>
            <a:ext cx="744697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dirty="0"/>
              <a:t>B         </a:t>
            </a:r>
            <a:r>
              <a:rPr lang="en-GB" sz="1600" dirty="0"/>
              <a:t>P2Y</a:t>
            </a:r>
            <a:r>
              <a:rPr lang="en-GB" sz="1600" baseline="-25000" dirty="0"/>
              <a:t>1</a:t>
            </a:r>
            <a:r>
              <a:rPr lang="en-GB" sz="1600" dirty="0"/>
              <a:t> Platelets                                P2Y</a:t>
            </a:r>
            <a:r>
              <a:rPr lang="en-GB" sz="1600" baseline="-25000" dirty="0"/>
              <a:t>1</a:t>
            </a:r>
            <a:r>
              <a:rPr lang="en-GB" sz="1600" dirty="0"/>
              <a:t> Muscle                                   P2Y</a:t>
            </a:r>
            <a:r>
              <a:rPr lang="en-GB" sz="1600" baseline="-25000" dirty="0"/>
              <a:t>12</a:t>
            </a:r>
            <a:r>
              <a:rPr lang="en-GB" sz="1600" dirty="0"/>
              <a:t> Platelets 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AED9E96-1724-A112-A2D7-10ADFDEECAF4}"/>
              </a:ext>
            </a:extLst>
          </p:cNvPr>
          <p:cNvSpPr txBox="1"/>
          <p:nvPr/>
        </p:nvSpPr>
        <p:spPr>
          <a:xfrm>
            <a:off x="6284797" y="1522337"/>
            <a:ext cx="4342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WT</a:t>
            </a:r>
            <a:endParaRPr lang="en-GB" sz="14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A5333E6-B8C4-EFE4-335B-3C33302810EF}"/>
              </a:ext>
            </a:extLst>
          </p:cNvPr>
          <p:cNvSpPr txBox="1"/>
          <p:nvPr/>
        </p:nvSpPr>
        <p:spPr>
          <a:xfrm>
            <a:off x="6691959" y="1360343"/>
            <a:ext cx="76014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 err="1"/>
              <a:t>Plt</a:t>
            </a:r>
            <a:endParaRPr lang="en-US" sz="1400" dirty="0"/>
          </a:p>
          <a:p>
            <a:pPr algn="ctr"/>
            <a:r>
              <a:rPr lang="en-US" sz="1400" dirty="0"/>
              <a:t>P2Y1-/-</a:t>
            </a:r>
            <a:endParaRPr lang="en-GB" sz="1400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FF5FAAF-BA22-EFA3-DD34-DAE0D7FABEB7}"/>
              </a:ext>
            </a:extLst>
          </p:cNvPr>
          <p:cNvSpPr txBox="1"/>
          <p:nvPr/>
        </p:nvSpPr>
        <p:spPr>
          <a:xfrm>
            <a:off x="3575591" y="1477348"/>
            <a:ext cx="4342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WT</a:t>
            </a:r>
            <a:endParaRPr lang="en-GB" sz="1400" dirty="0"/>
          </a:p>
        </p:txBody>
      </p:sp>
      <p:pic>
        <p:nvPicPr>
          <p:cNvPr id="22" name="Picture 21" descr="A close-up of a white background&#10;&#10;AI-generated content may be incorrect.">
            <a:extLst>
              <a:ext uri="{FF2B5EF4-FFF2-40B4-BE49-F238E27FC236}">
                <a16:creationId xmlns:a16="http://schemas.microsoft.com/office/drawing/2014/main" id="{683182AF-550D-82BA-438F-5D3C87753A9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711" r="60811" b="40914"/>
          <a:stretch>
            <a:fillRect/>
          </a:stretch>
        </p:blipFill>
        <p:spPr>
          <a:xfrm flipH="1">
            <a:off x="3206219" y="1710300"/>
            <a:ext cx="2029127" cy="3739347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165882BD-F0BC-BE49-0A3F-212439C0AAA3}"/>
              </a:ext>
            </a:extLst>
          </p:cNvPr>
          <p:cNvSpPr txBox="1"/>
          <p:nvPr/>
        </p:nvSpPr>
        <p:spPr>
          <a:xfrm>
            <a:off x="1788301" y="1397760"/>
            <a:ext cx="76014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 err="1"/>
              <a:t>Plt</a:t>
            </a:r>
            <a:endParaRPr lang="en-US" sz="1400" dirty="0"/>
          </a:p>
          <a:p>
            <a:pPr algn="ctr"/>
            <a:r>
              <a:rPr lang="en-US" sz="1400" dirty="0"/>
              <a:t>P2Y1-/-</a:t>
            </a:r>
            <a:endParaRPr lang="en-GB" sz="140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1B1D1C4-C6D6-991D-C6A3-71FF71E72C01}"/>
              </a:ext>
            </a:extLst>
          </p:cNvPr>
          <p:cNvSpPr txBox="1"/>
          <p:nvPr/>
        </p:nvSpPr>
        <p:spPr>
          <a:xfrm>
            <a:off x="1024249" y="1511151"/>
            <a:ext cx="4342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WT</a:t>
            </a:r>
            <a:endParaRPr lang="en-GB" sz="1400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9821F52-F4A8-40D8-1EB9-4C7D0B4171FE}"/>
              </a:ext>
            </a:extLst>
          </p:cNvPr>
          <p:cNvSpPr txBox="1"/>
          <p:nvPr/>
        </p:nvSpPr>
        <p:spPr>
          <a:xfrm>
            <a:off x="8594132" y="700134"/>
            <a:ext cx="168623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dirty="0"/>
              <a:t>C </a:t>
            </a:r>
            <a:r>
              <a:rPr lang="en-GB" sz="1600" dirty="0"/>
              <a:t>P2Y</a:t>
            </a:r>
            <a:r>
              <a:rPr lang="en-GB" sz="1600" baseline="-25000" dirty="0"/>
              <a:t>1</a:t>
            </a:r>
            <a:r>
              <a:rPr lang="en-GB" sz="1600" dirty="0"/>
              <a:t> Platelets </a:t>
            </a:r>
          </a:p>
        </p:txBody>
      </p:sp>
      <p:pic>
        <p:nvPicPr>
          <p:cNvPr id="26" name="Picture 25">
            <a:extLst>
              <a:ext uri="{FF2B5EF4-FFF2-40B4-BE49-F238E27FC236}">
                <a16:creationId xmlns:a16="http://schemas.microsoft.com/office/drawing/2014/main" id="{520CCCD4-F544-B653-72B2-F986F6839AC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343344" y="1865392"/>
            <a:ext cx="2577996" cy="3682355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0BFBA45D-7068-177C-C6EA-A65CCDF4CAE5}"/>
              </a:ext>
            </a:extLst>
          </p:cNvPr>
          <p:cNvSpPr txBox="1"/>
          <p:nvPr/>
        </p:nvSpPr>
        <p:spPr>
          <a:xfrm>
            <a:off x="9809604" y="1602801"/>
            <a:ext cx="5853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WT</a:t>
            </a:r>
            <a:endParaRPr lang="en-GB" sz="1400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15E976BC-BACA-4295-5D1B-6DF3F3508E78}"/>
              </a:ext>
            </a:extLst>
          </p:cNvPr>
          <p:cNvSpPr txBox="1"/>
          <p:nvPr/>
        </p:nvSpPr>
        <p:spPr>
          <a:xfrm>
            <a:off x="8902677" y="1472487"/>
            <a:ext cx="120626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err="1"/>
              <a:t>Plt</a:t>
            </a:r>
            <a:endParaRPr lang="en-US" sz="1400" dirty="0"/>
          </a:p>
          <a:p>
            <a:pPr algn="ctr"/>
            <a:r>
              <a:rPr lang="en-US" sz="1400" dirty="0"/>
              <a:t>P2Y1 -/-</a:t>
            </a:r>
            <a:endParaRPr lang="en-GB" sz="1400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1D73E9C5-943F-D432-9A9E-1F4649F795C8}"/>
              </a:ext>
            </a:extLst>
          </p:cNvPr>
          <p:cNvSpPr txBox="1"/>
          <p:nvPr/>
        </p:nvSpPr>
        <p:spPr>
          <a:xfrm>
            <a:off x="342618" y="2172202"/>
            <a:ext cx="608009" cy="351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75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1DAA80F7-312D-49CC-4761-5A4D5D3B5FC6}"/>
              </a:ext>
            </a:extLst>
          </p:cNvPr>
          <p:cNvSpPr txBox="1"/>
          <p:nvPr/>
        </p:nvSpPr>
        <p:spPr>
          <a:xfrm>
            <a:off x="346307" y="2827694"/>
            <a:ext cx="571257" cy="351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50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901E5DBF-9709-3686-2D20-AF6C9C02EDD9}"/>
              </a:ext>
            </a:extLst>
          </p:cNvPr>
          <p:cNvSpPr txBox="1"/>
          <p:nvPr/>
        </p:nvSpPr>
        <p:spPr>
          <a:xfrm>
            <a:off x="376210" y="182880"/>
            <a:ext cx="11458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Figure 1B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F6B93C6-84C4-6A3D-F4C6-9163619766A6}"/>
              </a:ext>
            </a:extLst>
          </p:cNvPr>
          <p:cNvSpPr txBox="1"/>
          <p:nvPr/>
        </p:nvSpPr>
        <p:spPr>
          <a:xfrm>
            <a:off x="4126249" y="1304708"/>
            <a:ext cx="76014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 err="1"/>
              <a:t>Plt</a:t>
            </a:r>
            <a:endParaRPr lang="en-US" sz="1400" dirty="0"/>
          </a:p>
          <a:p>
            <a:pPr algn="ctr"/>
            <a:r>
              <a:rPr lang="en-US" sz="1400" dirty="0"/>
              <a:t>P2Y1-/-</a:t>
            </a:r>
            <a:endParaRPr lang="en-GB" sz="1400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935F80CA-EC2A-9BAA-EA1F-3BED196A0AFF}"/>
              </a:ext>
            </a:extLst>
          </p:cNvPr>
          <p:cNvSpPr txBox="1"/>
          <p:nvPr/>
        </p:nvSpPr>
        <p:spPr>
          <a:xfrm>
            <a:off x="8240555" y="5449647"/>
            <a:ext cx="3295967" cy="11695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N.B. The experimenter added the </a:t>
            </a:r>
          </a:p>
          <a:p>
            <a:r>
              <a:rPr lang="en-GB" sz="1400" dirty="0"/>
              <a:t>platelets  from the WT mice into the </a:t>
            </a:r>
          </a:p>
          <a:p>
            <a:r>
              <a:rPr lang="en-GB" sz="1400" dirty="0"/>
              <a:t>right hand column for C. This has been</a:t>
            </a:r>
          </a:p>
          <a:p>
            <a:r>
              <a:rPr lang="en-GB" sz="1400" dirty="0"/>
              <a:t>flipped in the figure in the manuscript to </a:t>
            </a:r>
          </a:p>
          <a:p>
            <a:r>
              <a:rPr lang="en-GB" sz="1400" dirty="0"/>
              <a:t>avoid confusion with the other 3 WBs</a:t>
            </a:r>
          </a:p>
        </p:txBody>
      </p:sp>
      <p:grpSp>
        <p:nvGrpSpPr>
          <p:cNvPr id="32" name="Group 31">
            <a:extLst>
              <a:ext uri="{FF2B5EF4-FFF2-40B4-BE49-F238E27FC236}">
                <a16:creationId xmlns:a16="http://schemas.microsoft.com/office/drawing/2014/main" id="{ADF2E23D-0FF3-A657-BDCF-28B5AA1DA409}"/>
              </a:ext>
            </a:extLst>
          </p:cNvPr>
          <p:cNvGrpSpPr/>
          <p:nvPr/>
        </p:nvGrpSpPr>
        <p:grpSpPr>
          <a:xfrm>
            <a:off x="5514012" y="1917492"/>
            <a:ext cx="2171325" cy="3497678"/>
            <a:chOff x="5514012" y="1917492"/>
            <a:chExt cx="2171325" cy="3497678"/>
          </a:xfrm>
        </p:grpSpPr>
        <p:pic>
          <p:nvPicPr>
            <p:cNvPr id="6" name="Picture 5" descr="A close-up of a black and white photo&#10;&#10;AI-generated content may be incorrect.">
              <a:extLst>
                <a:ext uri="{FF2B5EF4-FFF2-40B4-BE49-F238E27FC236}">
                  <a16:creationId xmlns:a16="http://schemas.microsoft.com/office/drawing/2014/main" id="{2A952B49-6A93-4F22-555D-EF77FDD9977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100000"/>
                      </a14:imgEffect>
                      <a14:imgEffect>
                        <a14:brightnessContrast bright="-12000" contrast="4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137" r="12914" b="47493"/>
            <a:stretch>
              <a:fillRect/>
            </a:stretch>
          </p:blipFill>
          <p:spPr>
            <a:xfrm flipH="1">
              <a:off x="5699035" y="1937012"/>
              <a:ext cx="1986302" cy="3478158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7DF186EA-3595-38F3-DCC1-D6A1B3047276}"/>
                </a:ext>
              </a:extLst>
            </p:cNvPr>
            <p:cNvSpPr txBox="1"/>
            <p:nvPr/>
          </p:nvSpPr>
          <p:spPr>
            <a:xfrm>
              <a:off x="5589807" y="3003958"/>
              <a:ext cx="606978" cy="3882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/>
                <a:t>75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B23E61FF-E7A4-1D67-2DA7-21C2DDA1DB6B}"/>
                </a:ext>
              </a:extLst>
            </p:cNvPr>
            <p:cNvSpPr txBox="1"/>
            <p:nvPr/>
          </p:nvSpPr>
          <p:spPr>
            <a:xfrm>
              <a:off x="5591425" y="4003333"/>
              <a:ext cx="605358" cy="3882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/>
                <a:t>50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CF7855F1-8423-4EED-27CC-70EF08EAD299}"/>
                </a:ext>
              </a:extLst>
            </p:cNvPr>
            <p:cNvSpPr txBox="1"/>
            <p:nvPr/>
          </p:nvSpPr>
          <p:spPr>
            <a:xfrm>
              <a:off x="5591427" y="4902193"/>
              <a:ext cx="502016" cy="38824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/>
                <a:t>37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761A98B1-3F66-DC0D-FAB5-1438511F260B}"/>
                </a:ext>
              </a:extLst>
            </p:cNvPr>
            <p:cNvSpPr txBox="1"/>
            <p:nvPr/>
          </p:nvSpPr>
          <p:spPr>
            <a:xfrm>
              <a:off x="5514012" y="2431253"/>
              <a:ext cx="839801" cy="3882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/>
                <a:t>100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94522F24-5E6D-06D4-9ECC-3DD82478DC1F}"/>
                </a:ext>
              </a:extLst>
            </p:cNvPr>
            <p:cNvSpPr txBox="1"/>
            <p:nvPr/>
          </p:nvSpPr>
          <p:spPr>
            <a:xfrm>
              <a:off x="5514012" y="1917492"/>
              <a:ext cx="839801" cy="3882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/>
                <a:t>150</a:t>
              </a:r>
            </a:p>
          </p:txBody>
        </p:sp>
        <p:cxnSp>
          <p:nvCxnSpPr>
            <p:cNvPr id="3" name="Straight Arrow Connector 2">
              <a:extLst>
                <a:ext uri="{FF2B5EF4-FFF2-40B4-BE49-F238E27FC236}">
                  <a16:creationId xmlns:a16="http://schemas.microsoft.com/office/drawing/2014/main" id="{05CC0213-320C-7B68-04AD-F3B55CCB8B99}"/>
                </a:ext>
              </a:extLst>
            </p:cNvPr>
            <p:cNvCxnSpPr/>
            <p:nvPr/>
          </p:nvCxnSpPr>
          <p:spPr>
            <a:xfrm>
              <a:off x="5684060" y="5130270"/>
              <a:ext cx="394408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" name="Straight Arrow Connector 4">
              <a:extLst>
                <a:ext uri="{FF2B5EF4-FFF2-40B4-BE49-F238E27FC236}">
                  <a16:creationId xmlns:a16="http://schemas.microsoft.com/office/drawing/2014/main" id="{A9AC6B57-BCB5-8015-FDFA-195E3BECB59A}"/>
                </a:ext>
              </a:extLst>
            </p:cNvPr>
            <p:cNvCxnSpPr/>
            <p:nvPr/>
          </p:nvCxnSpPr>
          <p:spPr>
            <a:xfrm>
              <a:off x="5682456" y="4280570"/>
              <a:ext cx="394408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Arrow Connector 13">
              <a:extLst>
                <a:ext uri="{FF2B5EF4-FFF2-40B4-BE49-F238E27FC236}">
                  <a16:creationId xmlns:a16="http://schemas.microsoft.com/office/drawing/2014/main" id="{552EA087-DB6E-81C7-D387-9148EBE8E6C5}"/>
                </a:ext>
              </a:extLst>
            </p:cNvPr>
            <p:cNvCxnSpPr/>
            <p:nvPr/>
          </p:nvCxnSpPr>
          <p:spPr>
            <a:xfrm>
              <a:off x="5681122" y="3308953"/>
              <a:ext cx="394408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Arrow Connector 28">
              <a:extLst>
                <a:ext uri="{FF2B5EF4-FFF2-40B4-BE49-F238E27FC236}">
                  <a16:creationId xmlns:a16="http://schemas.microsoft.com/office/drawing/2014/main" id="{313DBCDE-1458-2EA0-FCC2-C17067DBFFC4}"/>
                </a:ext>
              </a:extLst>
            </p:cNvPr>
            <p:cNvCxnSpPr/>
            <p:nvPr/>
          </p:nvCxnSpPr>
          <p:spPr>
            <a:xfrm>
              <a:off x="5674973" y="2656841"/>
              <a:ext cx="394408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Arrow Connector 29">
              <a:extLst>
                <a:ext uri="{FF2B5EF4-FFF2-40B4-BE49-F238E27FC236}">
                  <a16:creationId xmlns:a16="http://schemas.microsoft.com/office/drawing/2014/main" id="{52A033D8-468C-B3B5-9C16-D528B3F3C320}"/>
                </a:ext>
              </a:extLst>
            </p:cNvPr>
            <p:cNvCxnSpPr/>
            <p:nvPr/>
          </p:nvCxnSpPr>
          <p:spPr>
            <a:xfrm>
              <a:off x="5674437" y="2179586"/>
              <a:ext cx="394408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31" name="Content Placeholder 4" descr="A x-ray of a person's body&#10;&#10;AI-generated content may be incorrect.">
            <a:extLst>
              <a:ext uri="{FF2B5EF4-FFF2-40B4-BE49-F238E27FC236}">
                <a16:creationId xmlns:a16="http://schemas.microsoft.com/office/drawing/2014/main" id="{80B16E18-6603-7DFC-0B96-CF4A298EB847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883" t="6924" r="27106" b="14881"/>
          <a:stretch>
            <a:fillRect/>
          </a:stretch>
        </p:blipFill>
        <p:spPr>
          <a:xfrm>
            <a:off x="593418" y="1888821"/>
            <a:ext cx="2196591" cy="3327743"/>
          </a:xfrm>
          <a:prstGeom prst="rect">
            <a:avLst/>
          </a:prstGeom>
        </p:spPr>
      </p:pic>
      <p:cxnSp>
        <p:nvCxnSpPr>
          <p:cNvPr id="33" name="Straight Arrow Connector 32">
            <a:extLst>
              <a:ext uri="{FF2B5EF4-FFF2-40B4-BE49-F238E27FC236}">
                <a16:creationId xmlns:a16="http://schemas.microsoft.com/office/drawing/2014/main" id="{D44891C8-6A78-0460-4842-1FFDE73E7392}"/>
              </a:ext>
            </a:extLst>
          </p:cNvPr>
          <p:cNvCxnSpPr/>
          <p:nvPr/>
        </p:nvCxnSpPr>
        <p:spPr>
          <a:xfrm>
            <a:off x="494299" y="2393799"/>
            <a:ext cx="394408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F8EA38E8-1EEB-BA2B-2B75-7EE05374C2EA}"/>
              </a:ext>
            </a:extLst>
          </p:cNvPr>
          <p:cNvCxnSpPr/>
          <p:nvPr/>
        </p:nvCxnSpPr>
        <p:spPr>
          <a:xfrm>
            <a:off x="489219" y="3069439"/>
            <a:ext cx="394408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2" name="Straight Arrow Connector 41">
            <a:extLst>
              <a:ext uri="{FF2B5EF4-FFF2-40B4-BE49-F238E27FC236}">
                <a16:creationId xmlns:a16="http://schemas.microsoft.com/office/drawing/2014/main" id="{0DEC043F-EE4E-9704-63D0-87EBABD0BC96}"/>
              </a:ext>
            </a:extLst>
          </p:cNvPr>
          <p:cNvCxnSpPr/>
          <p:nvPr/>
        </p:nvCxnSpPr>
        <p:spPr>
          <a:xfrm>
            <a:off x="494299" y="3572359"/>
            <a:ext cx="394408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BA72F6BF-2E65-D794-5ECD-71D2539951BC}"/>
              </a:ext>
            </a:extLst>
          </p:cNvPr>
          <p:cNvSpPr txBox="1"/>
          <p:nvPr/>
        </p:nvSpPr>
        <p:spPr>
          <a:xfrm>
            <a:off x="371708" y="3332666"/>
            <a:ext cx="532609" cy="351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37</a:t>
            </a:r>
          </a:p>
        </p:txBody>
      </p:sp>
      <p:cxnSp>
        <p:nvCxnSpPr>
          <p:cNvPr id="43" name="Straight Arrow Connector 42">
            <a:extLst>
              <a:ext uri="{FF2B5EF4-FFF2-40B4-BE49-F238E27FC236}">
                <a16:creationId xmlns:a16="http://schemas.microsoft.com/office/drawing/2014/main" id="{5CBBE714-56B8-6F87-7F27-6BA60489B3D3}"/>
              </a:ext>
            </a:extLst>
          </p:cNvPr>
          <p:cNvCxnSpPr/>
          <p:nvPr/>
        </p:nvCxnSpPr>
        <p:spPr>
          <a:xfrm>
            <a:off x="479059" y="4562959"/>
            <a:ext cx="394408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2BD8A543-F7DE-8CD6-B577-7C4533B3CA89}"/>
              </a:ext>
            </a:extLst>
          </p:cNvPr>
          <p:cNvSpPr txBox="1"/>
          <p:nvPr/>
        </p:nvSpPr>
        <p:spPr>
          <a:xfrm>
            <a:off x="371708" y="4313673"/>
            <a:ext cx="532609" cy="351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25</a:t>
            </a:r>
          </a:p>
        </p:txBody>
      </p: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71FF7BA6-CB08-12C2-4E48-AE0BBAE8F00C}"/>
              </a:ext>
            </a:extLst>
          </p:cNvPr>
          <p:cNvCxnSpPr/>
          <p:nvPr/>
        </p:nvCxnSpPr>
        <p:spPr>
          <a:xfrm>
            <a:off x="3145504" y="5120802"/>
            <a:ext cx="394408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id="{34F2B4CE-D415-D0C2-F3A3-EA5016AF743D}"/>
              </a:ext>
            </a:extLst>
          </p:cNvPr>
          <p:cNvSpPr txBox="1"/>
          <p:nvPr/>
        </p:nvSpPr>
        <p:spPr>
          <a:xfrm>
            <a:off x="2818534" y="4931387"/>
            <a:ext cx="4026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/>
              <a:t>37</a:t>
            </a:r>
          </a:p>
        </p:txBody>
      </p: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EFB348C5-7D29-D3C8-BA3D-6EA67C8C6B8B}"/>
              </a:ext>
            </a:extLst>
          </p:cNvPr>
          <p:cNvCxnSpPr/>
          <p:nvPr/>
        </p:nvCxnSpPr>
        <p:spPr>
          <a:xfrm>
            <a:off x="3132296" y="4441098"/>
            <a:ext cx="394408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51AD1647-BADB-00CF-B1C5-DBD862D3F09D}"/>
              </a:ext>
            </a:extLst>
          </p:cNvPr>
          <p:cNvSpPr txBox="1"/>
          <p:nvPr/>
        </p:nvSpPr>
        <p:spPr>
          <a:xfrm>
            <a:off x="2791102" y="4248706"/>
            <a:ext cx="4026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/>
              <a:t>50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F1312CC7-366A-C9E6-D29B-4DCD62DCD826}"/>
              </a:ext>
            </a:extLst>
          </p:cNvPr>
          <p:cNvSpPr txBox="1"/>
          <p:nvPr/>
        </p:nvSpPr>
        <p:spPr>
          <a:xfrm>
            <a:off x="2761430" y="3373137"/>
            <a:ext cx="5633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/>
              <a:t>75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1EA30B8E-28C3-EA6F-104D-DA46735D509E}"/>
              </a:ext>
            </a:extLst>
          </p:cNvPr>
          <p:cNvSpPr txBox="1"/>
          <p:nvPr/>
        </p:nvSpPr>
        <p:spPr>
          <a:xfrm>
            <a:off x="2655903" y="2801712"/>
            <a:ext cx="5633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/>
              <a:t>100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B892E5E1-6FF0-A715-5925-07719944FF62}"/>
              </a:ext>
            </a:extLst>
          </p:cNvPr>
          <p:cNvSpPr txBox="1"/>
          <p:nvPr/>
        </p:nvSpPr>
        <p:spPr>
          <a:xfrm>
            <a:off x="2646759" y="2326870"/>
            <a:ext cx="5633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/>
              <a:t>150</a:t>
            </a:r>
          </a:p>
        </p:txBody>
      </p:sp>
      <p:cxnSp>
        <p:nvCxnSpPr>
          <p:cNvPr id="51" name="Straight Arrow Connector 50">
            <a:extLst>
              <a:ext uri="{FF2B5EF4-FFF2-40B4-BE49-F238E27FC236}">
                <a16:creationId xmlns:a16="http://schemas.microsoft.com/office/drawing/2014/main" id="{F6D5F192-CD67-9D54-712A-F49A5CFE1C03}"/>
              </a:ext>
            </a:extLst>
          </p:cNvPr>
          <p:cNvCxnSpPr/>
          <p:nvPr/>
        </p:nvCxnSpPr>
        <p:spPr>
          <a:xfrm>
            <a:off x="3104864" y="3556162"/>
            <a:ext cx="394408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9398B9CF-491C-A9A1-D2CF-16BA86CC0A8B}"/>
              </a:ext>
            </a:extLst>
          </p:cNvPr>
          <p:cNvCxnSpPr/>
          <p:nvPr/>
        </p:nvCxnSpPr>
        <p:spPr>
          <a:xfrm>
            <a:off x="3101816" y="2968914"/>
            <a:ext cx="394408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3" name="Straight Arrow Connector 52">
            <a:extLst>
              <a:ext uri="{FF2B5EF4-FFF2-40B4-BE49-F238E27FC236}">
                <a16:creationId xmlns:a16="http://schemas.microsoft.com/office/drawing/2014/main" id="{8F9122DD-31F4-A574-A047-D396D4323C16}"/>
              </a:ext>
            </a:extLst>
          </p:cNvPr>
          <p:cNvCxnSpPr/>
          <p:nvPr/>
        </p:nvCxnSpPr>
        <p:spPr>
          <a:xfrm>
            <a:off x="3107912" y="2501554"/>
            <a:ext cx="394408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90272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9</TotalTime>
  <Words>81</Words>
  <Application>Microsoft Office PowerPoint</Application>
  <PresentationFormat>Widescreen</PresentationFormat>
  <Paragraphs>3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imon Pitchford</dc:creator>
  <cp:lastModifiedBy>Simon Pitchford</cp:lastModifiedBy>
  <cp:revision>2</cp:revision>
  <dcterms:created xsi:type="dcterms:W3CDTF">2026-01-13T08:42:45Z</dcterms:created>
  <dcterms:modified xsi:type="dcterms:W3CDTF">2026-02-16T13:13:53Z</dcterms:modified>
</cp:coreProperties>
</file>